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64C3038E-4A35-482C-B71D-0FD1E2DD911B}" type="datetime">
              <a:rPr b="0" lang="en-US" sz="1200" spc="-1" strike="noStrike">
                <a:solidFill>
                  <a:srgbClr val="000000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3123F952-DAE5-4620-9C91-DFFD4E409CBD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E7B0FD2F-F2A1-41C4-B8E4-FBF80C939807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PlaceHolder 1"/>
          <p:cNvSpPr>
            <a:spLocks noGrp="1"/>
          </p:cNvSpPr>
          <p:nvPr>
            <p:ph type="sldImg"/>
          </p:nvPr>
        </p:nvSpPr>
        <p:spPr>
          <a:xfrm>
            <a:off x="114444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8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241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txBody>
          <a:bodyPr lIns="4680" rIns="4680" tIns="4680" bIns="468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6850EA-F3A2-4166-9BFE-64CE4BE815F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931351-8485-466C-BFB4-E4C6536DF1F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00E7BB-8E75-40C2-8715-9995F8B03C3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B0F725-F80E-469D-8D1B-3D2A315B92D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BB52C1-538D-4ED2-A79A-948B0BC3F57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07543C-56B2-48B6-A82A-E06F561B958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5D2DAC-EB20-40C3-9816-EDE014DABCA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F7A9FA-E94D-498E-A0F5-8DAB1A172D4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B94C83-E972-4DFB-A40C-B173BD9D2FA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71912B-62C8-4CFD-B965-5ECBF2F41D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D139D6-1E1A-4D8D-949D-ADDBC74869C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FFA224-DAB7-40E1-8F60-0E83CE84E4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52F53F5A-18D0-428E-8DAB-76AA4BEF72AF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0114610B-0842-4E8F-8A1E-592C08754F4E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AutoShape 90"/>
          <p:cNvSpPr/>
          <p:nvPr/>
        </p:nvSpPr>
        <p:spPr>
          <a:xfrm rot="10799400">
            <a:off x="5633280" y="2814120"/>
            <a:ext cx="228600" cy="381240"/>
          </a:xfrm>
          <a:prstGeom prst="rightArrow">
            <a:avLst>
              <a:gd name="adj1" fmla="val 45833"/>
              <a:gd name="adj2" fmla="val 65972"/>
            </a:avLst>
          </a:prstGeom>
          <a:noFill/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AutoShape 90"/>
          <p:cNvSpPr/>
          <p:nvPr/>
        </p:nvSpPr>
        <p:spPr>
          <a:xfrm rot="10799400">
            <a:off x="6971760" y="2816280"/>
            <a:ext cx="228600" cy="380880"/>
          </a:xfrm>
          <a:prstGeom prst="rightArrow">
            <a:avLst>
              <a:gd name="adj1" fmla="val 45833"/>
              <a:gd name="adj2" fmla="val 65972"/>
            </a:avLst>
          </a:prstGeom>
          <a:noFill/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AutoShape 136"/>
          <p:cNvSpPr/>
          <p:nvPr/>
        </p:nvSpPr>
        <p:spPr>
          <a:xfrm rot="5400000">
            <a:off x="845640" y="3419280"/>
            <a:ext cx="365040" cy="381240"/>
          </a:xfrm>
          <a:prstGeom prst="rightArrow">
            <a:avLst>
              <a:gd name="adj1" fmla="val 45833"/>
              <a:gd name="adj2" fmla="val 51866"/>
            </a:avLst>
          </a:prstGeom>
          <a:noFill/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AutoShape 122"/>
          <p:cNvSpPr/>
          <p:nvPr/>
        </p:nvSpPr>
        <p:spPr>
          <a:xfrm>
            <a:off x="6705720" y="3905280"/>
            <a:ext cx="304560" cy="380880"/>
          </a:xfrm>
          <a:prstGeom prst="rightArrow">
            <a:avLst>
              <a:gd name="adj1" fmla="val 45833"/>
              <a:gd name="adj2" fmla="val 65972"/>
            </a:avLst>
          </a:prstGeom>
          <a:noFill/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12"/>
          <p:cNvSpPr/>
          <p:nvPr/>
        </p:nvSpPr>
        <p:spPr>
          <a:xfrm>
            <a:off x="0" y="6477120"/>
            <a:ext cx="4648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Gill Sans"/>
              </a:rPr>
              <a:t>Lennon et al. Supplementary Information Figure S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5"/>
          <p:cNvSpPr/>
          <p:nvPr/>
        </p:nvSpPr>
        <p:spPr>
          <a:xfrm>
            <a:off x="304920" y="1476360"/>
            <a:ext cx="1143000" cy="703080"/>
          </a:xfrm>
          <a:prstGeom prst="rect">
            <a:avLst/>
          </a:prstGeom>
          <a:noFill/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Gill Sans"/>
                <a:ea typeface="Gill Sans"/>
              </a:rPr>
              <a:t>Template Plat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Gill Sans"/>
                <a:ea typeface="Gill Sans"/>
              </a:rPr>
              <a:t>(2D barcoded tubes in 96-well format rack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AutoShape 10"/>
          <p:cNvSpPr/>
          <p:nvPr/>
        </p:nvSpPr>
        <p:spPr>
          <a:xfrm>
            <a:off x="1447920" y="1650960"/>
            <a:ext cx="228600" cy="380880"/>
          </a:xfrm>
          <a:prstGeom prst="rightArrow">
            <a:avLst>
              <a:gd name="adj1" fmla="val 45833"/>
              <a:gd name="adj2" fmla="val 65972"/>
            </a:avLst>
          </a:prstGeom>
          <a:noFill/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7"/>
          <p:cNvSpPr/>
          <p:nvPr/>
        </p:nvSpPr>
        <p:spPr>
          <a:xfrm>
            <a:off x="7162920" y="1476360"/>
            <a:ext cx="1257120" cy="703080"/>
          </a:xfrm>
          <a:prstGeom prst="rect">
            <a:avLst/>
          </a:prstGeom>
          <a:noFill/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Gill Sans"/>
                <a:ea typeface="Gill Sans"/>
              </a:rPr>
              <a:t>Reaction Cleanup (96w plate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Gill Sans"/>
                <a:ea typeface="Gill Sans"/>
              </a:rPr>
              <a:t>Brav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36"/>
          <p:cNvSpPr/>
          <p:nvPr/>
        </p:nvSpPr>
        <p:spPr>
          <a:xfrm>
            <a:off x="6019920" y="1414440"/>
            <a:ext cx="914400" cy="1007640"/>
          </a:xfrm>
          <a:prstGeom prst="rect">
            <a:avLst/>
          </a:prstGeom>
          <a:noFill/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Gill Sans"/>
                <a:ea typeface="Gill Sans"/>
              </a:rPr>
              <a:t>FragPol Reaction                    (96w plate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Gill Sans"/>
                <a:ea typeface="Gill Sans"/>
              </a:rPr>
              <a:t>Cycl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6"/>
          <p:cNvSpPr/>
          <p:nvPr/>
        </p:nvSpPr>
        <p:spPr>
          <a:xfrm>
            <a:off x="4648320" y="1476360"/>
            <a:ext cx="1143000" cy="703080"/>
          </a:xfrm>
          <a:prstGeom prst="rect">
            <a:avLst/>
          </a:prstGeom>
          <a:noFill/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Gill Sans"/>
                <a:ea typeface="Gill Sans"/>
              </a:rPr>
              <a:t>FragPol Setu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Gill Sans"/>
                <a:ea typeface="Gill Sans"/>
              </a:rPr>
              <a:t>(96w plate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Gill Sans"/>
                <a:ea typeface="Gill Sans"/>
              </a:rPr>
              <a:t>Brav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69"/>
          <p:cNvSpPr/>
          <p:nvPr/>
        </p:nvSpPr>
        <p:spPr>
          <a:xfrm>
            <a:off x="7194600" y="2565360"/>
            <a:ext cx="1301760" cy="855360"/>
          </a:xfrm>
          <a:prstGeom prst="rect">
            <a:avLst/>
          </a:prstGeom>
          <a:noFill/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Gill Sans"/>
                <a:ea typeface="Gill Sans"/>
              </a:rPr>
              <a:t>Adapter Ligation Setu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Gill Sans"/>
                <a:ea typeface="Gill Sans"/>
              </a:rPr>
              <a:t>(96w  plate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Gill Sans"/>
                <a:ea typeface="Gill Sans"/>
              </a:rPr>
              <a:t>Brav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74"/>
          <p:cNvSpPr/>
          <p:nvPr/>
        </p:nvSpPr>
        <p:spPr>
          <a:xfrm>
            <a:off x="5867280" y="2565360"/>
            <a:ext cx="1098720" cy="1007640"/>
          </a:xfrm>
          <a:prstGeom prst="rect">
            <a:avLst/>
          </a:prstGeom>
          <a:noFill/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Gill Sans"/>
                <a:ea typeface="Gill Sans"/>
              </a:rPr>
              <a:t>Adapter Ligation Reaction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Gill Sans"/>
                <a:ea typeface="Gill Sans"/>
              </a:rPr>
              <a:t>(96w plate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Gill Sans"/>
                <a:ea typeface="Gill Sans"/>
              </a:rPr>
              <a:t>Cycl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AutoShape 82"/>
          <p:cNvSpPr/>
          <p:nvPr/>
        </p:nvSpPr>
        <p:spPr>
          <a:xfrm>
            <a:off x="5791320" y="1650960"/>
            <a:ext cx="228600" cy="380880"/>
          </a:xfrm>
          <a:prstGeom prst="rightArrow">
            <a:avLst>
              <a:gd name="adj1" fmla="val 45833"/>
              <a:gd name="adj2" fmla="val 65972"/>
            </a:avLst>
          </a:prstGeom>
          <a:noFill/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AutoShape 83"/>
          <p:cNvSpPr/>
          <p:nvPr/>
        </p:nvSpPr>
        <p:spPr>
          <a:xfrm>
            <a:off x="6934320" y="1650960"/>
            <a:ext cx="228600" cy="380880"/>
          </a:xfrm>
          <a:prstGeom prst="rightArrow">
            <a:avLst>
              <a:gd name="adj1" fmla="val 45833"/>
              <a:gd name="adj2" fmla="val 65972"/>
            </a:avLst>
          </a:prstGeom>
          <a:noFill/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96"/>
          <p:cNvSpPr/>
          <p:nvPr/>
        </p:nvSpPr>
        <p:spPr>
          <a:xfrm>
            <a:off x="5529240" y="3668760"/>
            <a:ext cx="1176480" cy="855360"/>
          </a:xfrm>
          <a:prstGeom prst="rect">
            <a:avLst/>
          </a:prstGeom>
          <a:noFill/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Gill Sans"/>
                <a:ea typeface="Gill Sans"/>
              </a:rPr>
              <a:t>Cleanup/  Concentration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Gill Sans"/>
                <a:ea typeface="Gill Sans"/>
              </a:rPr>
              <a:t>(96w plate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Gill Sans"/>
                <a:ea typeface="Gill Sans"/>
              </a:rPr>
              <a:t>Brav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107"/>
          <p:cNvSpPr/>
          <p:nvPr/>
        </p:nvSpPr>
        <p:spPr>
          <a:xfrm>
            <a:off x="1671480" y="1476360"/>
            <a:ext cx="1295640" cy="703080"/>
          </a:xfrm>
          <a:prstGeom prst="rect">
            <a:avLst/>
          </a:prstGeom>
          <a:noFill/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Gill Sans"/>
                <a:ea typeface="Gill Sans"/>
              </a:rPr>
              <a:t>Shearing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Gill Sans"/>
                <a:ea typeface="Gill Sans"/>
              </a:rPr>
              <a:t>(96-well plate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Gill Sans"/>
                <a:ea typeface="Gill Sans"/>
              </a:rPr>
              <a:t> </a:t>
            </a:r>
            <a:r>
              <a:rPr b="0" lang="en-US" sz="1000" spc="-1" strike="noStrike">
                <a:solidFill>
                  <a:srgbClr val="262626"/>
                </a:solidFill>
                <a:latin typeface="Gill Sans"/>
                <a:ea typeface="Gill Sans"/>
              </a:rPr>
              <a:t>Covaris E-2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108"/>
          <p:cNvSpPr/>
          <p:nvPr/>
        </p:nvSpPr>
        <p:spPr>
          <a:xfrm>
            <a:off x="4043520" y="2565360"/>
            <a:ext cx="1595160" cy="855360"/>
          </a:xfrm>
          <a:prstGeom prst="rect">
            <a:avLst/>
          </a:prstGeom>
          <a:noFill/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Gill Sans"/>
                <a:ea typeface="Gill Sans"/>
              </a:rPr>
              <a:t>Adapter Ligation Reaction Cleanup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Gill Sans"/>
                <a:ea typeface="Gill Sans"/>
              </a:rPr>
              <a:t>(96w plate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Gill Sans"/>
                <a:ea typeface="Gill Sans"/>
              </a:rPr>
              <a:t>Brav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AutoShape 116"/>
          <p:cNvSpPr/>
          <p:nvPr/>
        </p:nvSpPr>
        <p:spPr>
          <a:xfrm rot="10799400">
            <a:off x="3814200" y="2814120"/>
            <a:ext cx="228600" cy="381240"/>
          </a:xfrm>
          <a:prstGeom prst="rightArrow">
            <a:avLst>
              <a:gd name="adj1" fmla="val 45833"/>
              <a:gd name="adj2" fmla="val 65972"/>
            </a:avLst>
          </a:prstGeom>
          <a:noFill/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117"/>
          <p:cNvSpPr/>
          <p:nvPr/>
        </p:nvSpPr>
        <p:spPr>
          <a:xfrm>
            <a:off x="2019240" y="2565360"/>
            <a:ext cx="1790640" cy="1007640"/>
          </a:xfrm>
          <a:prstGeom prst="rect">
            <a:avLst/>
          </a:prstGeom>
          <a:noFill/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Gill Sans"/>
                <a:ea typeface="Gill Sans"/>
              </a:rPr>
              <a:t>Binding to Immobilization Bead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Gill Sans"/>
                <a:ea typeface="Gill Sans"/>
              </a:rPr>
              <a:t>(96w plate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Gill Sans"/>
                <a:ea typeface="Gill Sans"/>
              </a:rPr>
              <a:t>(plate attached to tube roller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119"/>
          <p:cNvSpPr/>
          <p:nvPr/>
        </p:nvSpPr>
        <p:spPr>
          <a:xfrm>
            <a:off x="380880" y="2565360"/>
            <a:ext cx="1371600" cy="1007640"/>
          </a:xfrm>
          <a:prstGeom prst="rect">
            <a:avLst/>
          </a:prstGeom>
          <a:noFill/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Gill Sans"/>
                <a:ea typeface="Gill Sans"/>
              </a:rPr>
              <a:t>Wash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Gill Sans"/>
                <a:ea typeface="Gill Sans"/>
              </a:rPr>
              <a:t>Immobilization Beads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Gill Sans"/>
                <a:ea typeface="Gill Sans"/>
              </a:rPr>
              <a:t>(96w plate)          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Gill Sans"/>
                <a:ea typeface="Gill Sans"/>
              </a:rPr>
              <a:t>Brav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AutoShape 121"/>
          <p:cNvSpPr/>
          <p:nvPr/>
        </p:nvSpPr>
        <p:spPr>
          <a:xfrm rot="10799400">
            <a:off x="1751760" y="2814120"/>
            <a:ext cx="266760" cy="381240"/>
          </a:xfrm>
          <a:prstGeom prst="rightArrow">
            <a:avLst>
              <a:gd name="adj1" fmla="val 45833"/>
              <a:gd name="adj2" fmla="val 65972"/>
            </a:avLst>
          </a:prstGeom>
          <a:noFill/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125"/>
          <p:cNvSpPr/>
          <p:nvPr/>
        </p:nvSpPr>
        <p:spPr>
          <a:xfrm>
            <a:off x="571680" y="3784680"/>
            <a:ext cx="876240" cy="703080"/>
          </a:xfrm>
          <a:prstGeom prst="rect">
            <a:avLst/>
          </a:prstGeom>
          <a:noFill/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Gill Sans"/>
                <a:ea typeface="Gill Sans"/>
              </a:rPr>
              <a:t>Fill in Setu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Gill Sans"/>
                <a:ea typeface="Gill Sans"/>
              </a:rPr>
              <a:t>(96w plate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Gill Sans"/>
                <a:ea typeface="Gill Sans"/>
              </a:rPr>
              <a:t>Brav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127"/>
          <p:cNvSpPr/>
          <p:nvPr/>
        </p:nvSpPr>
        <p:spPr>
          <a:xfrm>
            <a:off x="3048120" y="3632040"/>
            <a:ext cx="1066680" cy="1159920"/>
          </a:xfrm>
          <a:prstGeom prst="rect">
            <a:avLst/>
          </a:prstGeom>
          <a:noFill/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Gill Sans"/>
                <a:ea typeface="Gill Sans"/>
              </a:rPr>
              <a:t>Wash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Gill Sans"/>
                <a:ea typeface="Gill Sans"/>
              </a:rPr>
              <a:t>Immobilization Beads 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Gill Sans"/>
                <a:ea typeface="Gill Sans"/>
              </a:rPr>
              <a:t>(96w plate)    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Gill Sans"/>
                <a:ea typeface="Gill Sans"/>
              </a:rPr>
              <a:t>Brav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131"/>
          <p:cNvSpPr/>
          <p:nvPr/>
        </p:nvSpPr>
        <p:spPr>
          <a:xfrm>
            <a:off x="4343400" y="3762360"/>
            <a:ext cx="914400" cy="703080"/>
          </a:xfrm>
          <a:prstGeom prst="rect">
            <a:avLst/>
          </a:prstGeom>
          <a:noFill/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Gill Sans"/>
                <a:ea typeface="Gill Sans"/>
              </a:rPr>
              <a:t>DNA Melt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Gill Sans"/>
                <a:ea typeface="Gill Sans"/>
              </a:rPr>
              <a:t>(96w plate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Gill Sans"/>
                <a:ea typeface="Gill Sans"/>
              </a:rPr>
              <a:t>Brav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AutoShape 132"/>
          <p:cNvSpPr/>
          <p:nvPr/>
        </p:nvSpPr>
        <p:spPr>
          <a:xfrm>
            <a:off x="4114800" y="3905280"/>
            <a:ext cx="228600" cy="380880"/>
          </a:xfrm>
          <a:prstGeom prst="rightArrow">
            <a:avLst>
              <a:gd name="adj1" fmla="val 45833"/>
              <a:gd name="adj2" fmla="val 65972"/>
            </a:avLst>
          </a:prstGeom>
          <a:noFill/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AutoShape 133"/>
          <p:cNvSpPr/>
          <p:nvPr/>
        </p:nvSpPr>
        <p:spPr>
          <a:xfrm>
            <a:off x="5257800" y="3909960"/>
            <a:ext cx="271440" cy="380880"/>
          </a:xfrm>
          <a:prstGeom prst="rightArrow">
            <a:avLst>
              <a:gd name="adj1" fmla="val 45833"/>
              <a:gd name="adj2" fmla="val 65972"/>
            </a:avLst>
          </a:prstGeom>
          <a:noFill/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135"/>
          <p:cNvSpPr/>
          <p:nvPr/>
        </p:nvSpPr>
        <p:spPr>
          <a:xfrm>
            <a:off x="1714680" y="3762360"/>
            <a:ext cx="1028520" cy="1007640"/>
          </a:xfrm>
          <a:prstGeom prst="rect">
            <a:avLst/>
          </a:prstGeom>
          <a:noFill/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Gill Sans"/>
                <a:ea typeface="Gill Sans"/>
              </a:rPr>
              <a:t>Fill in Reaction                    (96w plate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Gill Sans"/>
                <a:ea typeface="Gill Sans"/>
              </a:rPr>
              <a:t>Cycl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7"/>
          <p:cNvSpPr/>
          <p:nvPr/>
        </p:nvSpPr>
        <p:spPr>
          <a:xfrm>
            <a:off x="3200400" y="1476360"/>
            <a:ext cx="1219320" cy="703080"/>
          </a:xfrm>
          <a:prstGeom prst="rect">
            <a:avLst/>
          </a:prstGeom>
          <a:noFill/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Gill Sans"/>
                <a:ea typeface="Gill Sans"/>
              </a:rPr>
              <a:t>Reaction Cleanup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Gill Sans"/>
                <a:ea typeface="Gill Sans"/>
              </a:rPr>
              <a:t>(96w plate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Gill Sans"/>
                <a:ea typeface="Gill Sans"/>
              </a:rPr>
              <a:t>Brav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AutoShape 82"/>
          <p:cNvSpPr/>
          <p:nvPr/>
        </p:nvSpPr>
        <p:spPr>
          <a:xfrm>
            <a:off x="2971800" y="1650960"/>
            <a:ext cx="228600" cy="380880"/>
          </a:xfrm>
          <a:prstGeom prst="rightArrow">
            <a:avLst>
              <a:gd name="adj1" fmla="val 45833"/>
              <a:gd name="adj2" fmla="val 65972"/>
            </a:avLst>
          </a:prstGeom>
          <a:noFill/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96"/>
          <p:cNvSpPr/>
          <p:nvPr/>
        </p:nvSpPr>
        <p:spPr>
          <a:xfrm>
            <a:off x="7010280" y="3762360"/>
            <a:ext cx="1486080" cy="855360"/>
          </a:xfrm>
          <a:prstGeom prst="rect">
            <a:avLst/>
          </a:prstGeom>
          <a:noFill/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Gill Sans"/>
                <a:ea typeface="Gill Sans"/>
              </a:rPr>
              <a:t>Pre-QC ssDNA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262626"/>
                </a:solidFill>
                <a:latin typeface="Gill Sans"/>
                <a:ea typeface="Gill Sans"/>
              </a:rPr>
              <a:t>(2D barcoded tubes in 96-well format rack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AutoShape 82"/>
          <p:cNvSpPr/>
          <p:nvPr/>
        </p:nvSpPr>
        <p:spPr>
          <a:xfrm>
            <a:off x="4419720" y="1650960"/>
            <a:ext cx="228600" cy="380880"/>
          </a:xfrm>
          <a:prstGeom prst="rightArrow">
            <a:avLst>
              <a:gd name="adj1" fmla="val 45833"/>
              <a:gd name="adj2" fmla="val 65972"/>
            </a:avLst>
          </a:prstGeom>
          <a:noFill/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AutoShape 89"/>
          <p:cNvSpPr/>
          <p:nvPr/>
        </p:nvSpPr>
        <p:spPr>
          <a:xfrm rot="5400000">
            <a:off x="7631280" y="2173320"/>
            <a:ext cx="358560" cy="380880"/>
          </a:xfrm>
          <a:prstGeom prst="rightArrow">
            <a:avLst>
              <a:gd name="adj1" fmla="val 45833"/>
              <a:gd name="adj2" fmla="val 55870"/>
            </a:avLst>
          </a:prstGeom>
          <a:noFill/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AutoShape 128"/>
          <p:cNvSpPr/>
          <p:nvPr/>
        </p:nvSpPr>
        <p:spPr>
          <a:xfrm>
            <a:off x="2743200" y="3909960"/>
            <a:ext cx="266760" cy="380880"/>
          </a:xfrm>
          <a:prstGeom prst="rightArrow">
            <a:avLst>
              <a:gd name="adj1" fmla="val 45833"/>
              <a:gd name="adj2" fmla="val 65972"/>
            </a:avLst>
          </a:prstGeom>
          <a:noFill/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AutoShape 121"/>
          <p:cNvSpPr/>
          <p:nvPr/>
        </p:nvSpPr>
        <p:spPr>
          <a:xfrm>
            <a:off x="1447920" y="3909960"/>
            <a:ext cx="266760" cy="380880"/>
          </a:xfrm>
          <a:prstGeom prst="rightArrow">
            <a:avLst>
              <a:gd name="adj1" fmla="val 45833"/>
              <a:gd name="adj2" fmla="val 65972"/>
            </a:avLst>
          </a:prstGeom>
          <a:noFill/>
          <a:ln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3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2-07T18:23:02Z</dcterms:created>
  <dc:creator>Niall Lennon</dc:creator>
  <dc:description/>
  <dc:language>en-US</dc:language>
  <cp:lastModifiedBy>Niall Lennon</cp:lastModifiedBy>
  <dcterms:modified xsi:type="dcterms:W3CDTF">2010-01-28T19:49:03Z</dcterms:modified>
  <cp:revision>15</cp:revision>
  <dc:subject/>
  <dc:title>Slide 1</dc:title>
</cp:coreProperties>
</file>